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sec, Jan" initials="LJ" lastIdx="3" clrIdx="0">
    <p:extLst>
      <p:ext uri="{19B8F6BF-5375-455C-9EA6-DF929625EA0E}">
        <p15:presenceInfo xmlns="" xmlns:p15="http://schemas.microsoft.com/office/powerpoint/2012/main" userId="S-1-5-21-126249482-453980865-1851928258-304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FF3399"/>
    <a:srgbClr val="D60093"/>
    <a:srgbClr val="FF0066"/>
    <a:srgbClr val="FFFF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6324" autoAdjust="0"/>
    <p:restoredTop sz="84919" autoAdjust="0"/>
  </p:normalViewPr>
  <p:slideViewPr>
    <p:cSldViewPr>
      <p:cViewPr>
        <p:scale>
          <a:sx n="112" d="100"/>
          <a:sy n="112" d="100"/>
        </p:scale>
        <p:origin x="-960" y="19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3.6107491704402431E-2"/>
          <c:y val="2.7923211169284486E-2"/>
          <c:w val="0.94672512438749701"/>
          <c:h val="0.76711464731830026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2">
                <a:lumMod val="50000"/>
              </a:schemeClr>
            </a:solidFill>
            <a:ln>
              <a:noFill/>
            </a:ln>
            <a:effectLst>
              <a:innerShdw blurRad="114300">
                <a:schemeClr val="accent1"/>
              </a:innerShdw>
            </a:effectLst>
          </c:spPr>
          <c:dPt>
            <c:idx val="5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6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6B8F-41C3-9A8B-4FEF1E8432BC}"/>
              </c:ext>
            </c:extLst>
          </c:dPt>
          <c:dPt>
            <c:idx val="7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6B8F-41C3-9A8B-4FEF1E8432BC}"/>
              </c:ext>
            </c:extLst>
          </c:dPt>
          <c:dPt>
            <c:idx val="8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6-6B8F-41C3-9A8B-4FEF1E8432BC}"/>
              </c:ext>
            </c:extLst>
          </c:dPt>
          <c:dPt>
            <c:idx val="9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E-6B8F-41C3-9A8B-4FEF1E8432BC}"/>
              </c:ext>
            </c:extLst>
          </c:dPt>
          <c:dPt>
            <c:idx val="10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11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B8F-41C3-9A8B-4FEF1E8432BC}"/>
              </c:ext>
            </c:extLst>
          </c:dPt>
          <c:dPt>
            <c:idx val="12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C-6B8F-41C3-9A8B-4FEF1E8432BC}"/>
              </c:ext>
            </c:extLst>
          </c:dPt>
          <c:dPt>
            <c:idx val="13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6B8F-41C3-9A8B-4FEF1E8432BC}"/>
              </c:ext>
            </c:extLst>
          </c:dPt>
          <c:dPt>
            <c:idx val="14"/>
            <c:spPr>
              <a:solidFill>
                <a:schemeClr val="tx2">
                  <a:lumMod val="20000"/>
                  <a:lumOff val="8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F-6B8F-41C3-9A8B-4FEF1E8432BC}"/>
              </c:ext>
            </c:extLst>
          </c:dPt>
          <c:dPt>
            <c:idx val="15"/>
            <c:spPr>
              <a:solidFill>
                <a:schemeClr val="accent3">
                  <a:lumMod val="5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16"/>
            <c:spPr>
              <a:solidFill>
                <a:schemeClr val="accent3">
                  <a:lumMod val="5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6B8F-41C3-9A8B-4FEF1E8432BC}"/>
              </c:ext>
            </c:extLst>
          </c:dPt>
          <c:dPt>
            <c:idx val="17"/>
            <c:spPr>
              <a:solidFill>
                <a:schemeClr val="accent3">
                  <a:lumMod val="5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6B8F-41C3-9A8B-4FEF1E8432BC}"/>
              </c:ext>
            </c:extLst>
          </c:dPt>
          <c:dPt>
            <c:idx val="18"/>
            <c:spPr>
              <a:solidFill>
                <a:schemeClr val="accent3">
                  <a:lumMod val="50000"/>
                </a:schemeClr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8-6B8F-41C3-9A8B-4FEF1E8432BC}"/>
              </c:ext>
            </c:extLst>
          </c:dPt>
          <c:dPt>
            <c:idx val="19"/>
            <c:spPr>
              <a:solidFill>
                <a:srgbClr val="00FFFF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20"/>
            <c:spPr>
              <a:solidFill>
                <a:srgbClr val="00FFFF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6B8F-41C3-9A8B-4FEF1E8432BC}"/>
              </c:ext>
            </c:extLst>
          </c:dPt>
          <c:dPt>
            <c:idx val="21"/>
            <c:spPr>
              <a:solidFill>
                <a:srgbClr val="00FFFF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E-6B8F-41C3-9A8B-4FEF1E8432BC}"/>
              </c:ext>
            </c:extLst>
          </c:dPt>
          <c:dPt>
            <c:idx val="22"/>
            <c:spPr>
              <a:solidFill>
                <a:srgbClr val="00FFFF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9-6B8F-41C3-9A8B-4FEF1E8432BC}"/>
              </c:ext>
            </c:extLst>
          </c:dPt>
          <c:dPt>
            <c:idx val="23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</c:dPt>
          <c:dPt>
            <c:idx val="24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6-6B8F-41C3-9A8B-4FEF1E8432BC}"/>
              </c:ext>
            </c:extLst>
          </c:dPt>
          <c:dPt>
            <c:idx val="25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6B8F-41C3-9A8B-4FEF1E8432BC}"/>
              </c:ext>
            </c:extLst>
          </c:dPt>
          <c:dPt>
            <c:idx val="26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A-6B8F-41C3-9A8B-4FEF1E8432BC}"/>
              </c:ext>
            </c:extLst>
          </c:dPt>
          <c:dPt>
            <c:idx val="27"/>
            <c:spPr>
              <a:solidFill>
                <a:srgbClr val="FFC000"/>
              </a:solidFill>
              <a:ln>
                <a:noFill/>
              </a:ln>
              <a:effectLst>
                <a:innerShdw blurRad="114300">
                  <a:schemeClr val="accent1"/>
                </a:inn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0-6B8F-41C3-9A8B-4FEF1E8432BC}"/>
              </c:ext>
            </c:extLst>
          </c:dPt>
          <c:errBars>
            <c:errBarType val="both"/>
            <c:errValType val="cust"/>
            <c:plus>
              <c:numRef>
                <c:f>CEs!$B$124:$AC$124</c:f>
                <c:numCache>
                  <c:formatCode>General</c:formatCode>
                  <c:ptCount val="28"/>
                  <c:pt idx="0">
                    <c:v>0.13542497563761188</c:v>
                  </c:pt>
                  <c:pt idx="1">
                    <c:v>4.5412834252685962E-2</c:v>
                  </c:pt>
                  <c:pt idx="2">
                    <c:v>0.14543230007392943</c:v>
                  </c:pt>
                  <c:pt idx="3">
                    <c:v>0.16138604652378782</c:v>
                  </c:pt>
                  <c:pt idx="4">
                    <c:v>7.3295380601134191E-2</c:v>
                  </c:pt>
                  <c:pt idx="5">
                    <c:v>7.6382837228449211E-3</c:v>
                  </c:pt>
                  <c:pt idx="6">
                    <c:v>5.2371879416861543E-3</c:v>
                  </c:pt>
                  <c:pt idx="7">
                    <c:v>1.18312668102149E-2</c:v>
                  </c:pt>
                  <c:pt idx="8">
                    <c:v>4.0867870689832789E-2</c:v>
                  </c:pt>
                  <c:pt idx="9">
                    <c:v>6.8603216131107175E-2</c:v>
                  </c:pt>
                  <c:pt idx="10">
                    <c:v>7.0985745204803025E-2</c:v>
                  </c:pt>
                  <c:pt idx="11">
                    <c:v>5.4482214144171877E-3</c:v>
                  </c:pt>
                  <c:pt idx="12">
                    <c:v>9.3289437597574749E-3</c:v>
                  </c:pt>
                  <c:pt idx="13">
                    <c:v>7.0730344463647718E-2</c:v>
                  </c:pt>
                  <c:pt idx="14">
                    <c:v>1.6767598203133557E-2</c:v>
                  </c:pt>
                  <c:pt idx="15">
                    <c:v>7.3181522821077927E-2</c:v>
                  </c:pt>
                  <c:pt idx="16">
                    <c:v>2.8729926400427237E-3</c:v>
                  </c:pt>
                  <c:pt idx="17">
                    <c:v>4.7078928693374864E-2</c:v>
                  </c:pt>
                  <c:pt idx="18">
                    <c:v>1.4824750825355155E-2</c:v>
                  </c:pt>
                  <c:pt idx="19">
                    <c:v>0.14548017475003158</c:v>
                  </c:pt>
                  <c:pt idx="20">
                    <c:v>4.5026024289517011E-3</c:v>
                  </c:pt>
                  <c:pt idx="21">
                    <c:v>8.6525222194646201E-2</c:v>
                  </c:pt>
                  <c:pt idx="22">
                    <c:v>0.20577129627548665</c:v>
                  </c:pt>
                  <c:pt idx="23">
                    <c:v>9.7191070737978169E-2</c:v>
                  </c:pt>
                  <c:pt idx="24">
                    <c:v>6.8244070390138288E-3</c:v>
                  </c:pt>
                  <c:pt idx="25">
                    <c:v>2.3217964244202052E-2</c:v>
                  </c:pt>
                  <c:pt idx="26">
                    <c:v>0.12273065144676359</c:v>
                  </c:pt>
                  <c:pt idx="27">
                    <c:v>2.9313080145919893E-2</c:v>
                  </c:pt>
                </c:numCache>
              </c:numRef>
            </c:plus>
            <c:minus>
              <c:numRef>
                <c:f>CEs!$B$124:$AC$124</c:f>
                <c:numCache>
                  <c:formatCode>General</c:formatCode>
                  <c:ptCount val="28"/>
                  <c:pt idx="0">
                    <c:v>0.13542497563761188</c:v>
                  </c:pt>
                  <c:pt idx="1">
                    <c:v>4.5412834252685962E-2</c:v>
                  </c:pt>
                  <c:pt idx="2">
                    <c:v>0.14543230007392943</c:v>
                  </c:pt>
                  <c:pt idx="3">
                    <c:v>0.16138604652378782</c:v>
                  </c:pt>
                  <c:pt idx="4">
                    <c:v>7.3295380601134191E-2</c:v>
                  </c:pt>
                  <c:pt idx="5">
                    <c:v>7.6382837228449211E-3</c:v>
                  </c:pt>
                  <c:pt idx="6">
                    <c:v>5.2371879416861543E-3</c:v>
                  </c:pt>
                  <c:pt idx="7">
                    <c:v>1.18312668102149E-2</c:v>
                  </c:pt>
                  <c:pt idx="8">
                    <c:v>4.0867870689832789E-2</c:v>
                  </c:pt>
                  <c:pt idx="9">
                    <c:v>6.8603216131107175E-2</c:v>
                  </c:pt>
                  <c:pt idx="10">
                    <c:v>7.0985745204803025E-2</c:v>
                  </c:pt>
                  <c:pt idx="11">
                    <c:v>5.4482214144171877E-3</c:v>
                  </c:pt>
                  <c:pt idx="12">
                    <c:v>9.3289437597574749E-3</c:v>
                  </c:pt>
                  <c:pt idx="13">
                    <c:v>7.0730344463647718E-2</c:v>
                  </c:pt>
                  <c:pt idx="14">
                    <c:v>1.6767598203133557E-2</c:v>
                  </c:pt>
                  <c:pt idx="15">
                    <c:v>7.3181522821077927E-2</c:v>
                  </c:pt>
                  <c:pt idx="16">
                    <c:v>2.8729926400427237E-3</c:v>
                  </c:pt>
                  <c:pt idx="17">
                    <c:v>4.7078928693374864E-2</c:v>
                  </c:pt>
                  <c:pt idx="18">
                    <c:v>1.4824750825355155E-2</c:v>
                  </c:pt>
                  <c:pt idx="19">
                    <c:v>0.14548017475003158</c:v>
                  </c:pt>
                  <c:pt idx="20">
                    <c:v>4.5026024289517011E-3</c:v>
                  </c:pt>
                  <c:pt idx="21">
                    <c:v>8.6525222194646201E-2</c:v>
                  </c:pt>
                  <c:pt idx="22">
                    <c:v>0.20577129627548665</c:v>
                  </c:pt>
                  <c:pt idx="23">
                    <c:v>9.7191070737978169E-2</c:v>
                  </c:pt>
                  <c:pt idx="24">
                    <c:v>6.8244070390138288E-3</c:v>
                  </c:pt>
                  <c:pt idx="25">
                    <c:v>2.3217964244202052E-2</c:v>
                  </c:pt>
                  <c:pt idx="26">
                    <c:v>0.12273065144676359</c:v>
                  </c:pt>
                  <c:pt idx="27">
                    <c:v>2.9313080145919893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multiLvlStrRef>
              <c:f>CEs!$B$121:$AC$122</c:f>
              <c:multiLvlStrCache>
                <c:ptCount val="28"/>
                <c:lvl>
                  <c:pt idx="0">
                    <c:v>Nor</c:v>
                  </c:pt>
                  <c:pt idx="1">
                    <c:v>LPDS</c:v>
                  </c:pt>
                  <c:pt idx="2">
                    <c:v>LS</c:v>
                  </c:pt>
                  <c:pt idx="3">
                    <c:v>Hyp</c:v>
                  </c:pt>
                  <c:pt idx="4">
                    <c:v>Hyp+LS</c:v>
                  </c:pt>
                  <c:pt idx="5">
                    <c:v>Nor</c:v>
                  </c:pt>
                  <c:pt idx="6">
                    <c:v>LPDS</c:v>
                  </c:pt>
                  <c:pt idx="7">
                    <c:v>LS</c:v>
                  </c:pt>
                  <c:pt idx="8">
                    <c:v>Hyp</c:v>
                  </c:pt>
                  <c:pt idx="9">
                    <c:v>Hyp+LS</c:v>
                  </c:pt>
                  <c:pt idx="10">
                    <c:v>Nor</c:v>
                  </c:pt>
                  <c:pt idx="11">
                    <c:v>LPDS</c:v>
                  </c:pt>
                  <c:pt idx="12">
                    <c:v>LS</c:v>
                  </c:pt>
                  <c:pt idx="13">
                    <c:v>Hyp</c:v>
                  </c:pt>
                  <c:pt idx="14">
                    <c:v>Hyp+LS</c:v>
                  </c:pt>
                  <c:pt idx="15">
                    <c:v>N</c:v>
                  </c:pt>
                  <c:pt idx="16">
                    <c:v>LPDS</c:v>
                  </c:pt>
                  <c:pt idx="17">
                    <c:v>LS</c:v>
                  </c:pt>
                  <c:pt idx="18">
                    <c:v>Hyp</c:v>
                  </c:pt>
                  <c:pt idx="19">
                    <c:v>N</c:v>
                  </c:pt>
                  <c:pt idx="20">
                    <c:v>LPDS</c:v>
                  </c:pt>
                  <c:pt idx="21">
                    <c:v>LS</c:v>
                  </c:pt>
                  <c:pt idx="22">
                    <c:v>Hyp</c:v>
                  </c:pt>
                  <c:pt idx="23">
                    <c:v>N</c:v>
                  </c:pt>
                  <c:pt idx="24">
                    <c:v>LPDS</c:v>
                  </c:pt>
                  <c:pt idx="25">
                    <c:v>LS</c:v>
                  </c:pt>
                  <c:pt idx="26">
                    <c:v>Hyp</c:v>
                  </c:pt>
                  <c:pt idx="27">
                    <c:v>Hyp+LS</c:v>
                  </c:pt>
                </c:lvl>
                <c:lvl>
                  <c:pt idx="0">
                    <c:v>KCl22</c:v>
                  </c:pt>
                  <c:pt idx="5">
                    <c:v>KG1</c:v>
                  </c:pt>
                  <c:pt idx="10">
                    <c:v>KU812</c:v>
                  </c:pt>
                  <c:pt idx="15">
                    <c:v>SW480</c:v>
                  </c:pt>
                  <c:pt idx="19">
                    <c:v>SW620</c:v>
                  </c:pt>
                  <c:pt idx="23">
                    <c:v>A549</c:v>
                  </c:pt>
                </c:lvl>
              </c:multiLvlStrCache>
            </c:multiLvlStrRef>
          </c:cat>
          <c:val>
            <c:numRef>
              <c:f>CEs!$B$123:$AC$123</c:f>
              <c:numCache>
                <c:formatCode>General</c:formatCode>
                <c:ptCount val="28"/>
                <c:pt idx="0">
                  <c:v>1</c:v>
                </c:pt>
                <c:pt idx="1">
                  <c:v>0.39760293345501396</c:v>
                </c:pt>
                <c:pt idx="2">
                  <c:v>0.39506319460939371</c:v>
                </c:pt>
                <c:pt idx="3">
                  <c:v>0.85679482691802888</c:v>
                </c:pt>
                <c:pt idx="4">
                  <c:v>0.32235071758072797</c:v>
                </c:pt>
                <c:pt idx="5">
                  <c:v>1</c:v>
                </c:pt>
                <c:pt idx="6">
                  <c:v>0.64483175838145013</c:v>
                </c:pt>
                <c:pt idx="7">
                  <c:v>0.46657987839431503</c:v>
                </c:pt>
                <c:pt idx="8">
                  <c:v>1.4245294288821158</c:v>
                </c:pt>
                <c:pt idx="9">
                  <c:v>0.5564700657038274</c:v>
                </c:pt>
                <c:pt idx="10">
                  <c:v>1</c:v>
                </c:pt>
                <c:pt idx="11">
                  <c:v>0.15677776125599671</c:v>
                </c:pt>
                <c:pt idx="12">
                  <c:v>0.16784246860608823</c:v>
                </c:pt>
                <c:pt idx="13">
                  <c:v>0.64564021140635608</c:v>
                </c:pt>
                <c:pt idx="14">
                  <c:v>0.16933210383282779</c:v>
                </c:pt>
                <c:pt idx="15">
                  <c:v>1</c:v>
                </c:pt>
                <c:pt idx="16">
                  <c:v>0.10020547807835721</c:v>
                </c:pt>
                <c:pt idx="17">
                  <c:v>0.16316330318371525</c:v>
                </c:pt>
                <c:pt idx="18">
                  <c:v>0.92748423980259886</c:v>
                </c:pt>
                <c:pt idx="19">
                  <c:v>1</c:v>
                </c:pt>
                <c:pt idx="20">
                  <c:v>9.8258326508046973E-2</c:v>
                </c:pt>
                <c:pt idx="21">
                  <c:v>0.10579854182439952</c:v>
                </c:pt>
                <c:pt idx="22">
                  <c:v>0.71697354277667669</c:v>
                </c:pt>
                <c:pt idx="23">
                  <c:v>1</c:v>
                </c:pt>
                <c:pt idx="24">
                  <c:v>7.0130108308324959E-2</c:v>
                </c:pt>
                <c:pt idx="25">
                  <c:v>0.21303487804598464</c:v>
                </c:pt>
                <c:pt idx="26">
                  <c:v>0.7437676835275121</c:v>
                </c:pt>
                <c:pt idx="27">
                  <c:v>0.174029672394287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B8F-41C3-9A8B-4FEF1E8432BC}"/>
            </c:ext>
          </c:extLst>
        </c:ser>
        <c:gapWidth val="164"/>
        <c:overlap val="-22"/>
        <c:axId val="75520256"/>
        <c:axId val="75526144"/>
      </c:barChart>
      <c:catAx>
        <c:axId val="7552025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1905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526144"/>
        <c:crosses val="autoZero"/>
        <c:auto val="1"/>
        <c:lblAlgn val="ctr"/>
        <c:lblOffset val="100"/>
      </c:catAx>
      <c:valAx>
        <c:axId val="75526144"/>
        <c:scaling>
          <c:orientation val="minMax"/>
        </c:scaling>
        <c:axPos val="l"/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520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A15945-6199-4706-9261-44B47929DB86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94DFB6-8908-4C5C-81EA-23F4DA78596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20663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1: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ld-changes in total cholesterol ester (CE) content </a:t>
            </a:r>
            <a:r>
              <a:rPr lang="en-US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CL22 (Leukemia), KG1 (Leukemia), KU812 (Leukemia), SW480 (Colon cancer), SW620 (Colon cancer) and A549 (Lung Cancer)</a:t>
            </a:r>
            <a:r>
              <a:rPr lang="en-US" sz="1200" u="none" strike="noStrike" baseline="0" smtClean="0">
                <a:effectLst/>
              </a:rPr>
              <a:t> </a:t>
            </a:r>
            <a:r>
              <a:rPr lang="en-US" sz="1200" u="none" strike="noStrike" baseline="0" dirty="0" smtClean="0">
                <a:effectLst/>
              </a:rPr>
              <a:t>cell lines under Nor, LPDS, LS, </a:t>
            </a:r>
            <a:r>
              <a:rPr lang="en-US" sz="1200" u="none" strike="noStrike" baseline="0" dirty="0" err="1" smtClean="0">
                <a:effectLst/>
              </a:rPr>
              <a:t>Hyp</a:t>
            </a:r>
            <a:r>
              <a:rPr lang="en-US" sz="1200" u="none" strike="noStrike" baseline="0" dirty="0" smtClean="0">
                <a:effectLst/>
              </a:rPr>
              <a:t> or </a:t>
            </a:r>
            <a:r>
              <a:rPr lang="en-US" sz="1200" u="none" strike="noStrike" baseline="0" dirty="0" err="1" smtClean="0">
                <a:effectLst/>
              </a:rPr>
              <a:t>Hyp+LS</a:t>
            </a:r>
            <a:r>
              <a:rPr lang="en-US" sz="1200" u="none" strike="noStrike" baseline="0" dirty="0" smtClean="0">
                <a:effectLst/>
              </a:rPr>
              <a:t> conditions.</a:t>
            </a:r>
            <a:endParaRPr lang="en-US" b="1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94DFB6-8908-4C5C-81EA-23F4DA78596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836304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45721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41710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05683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56111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98847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6255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4732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61549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39769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0883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99800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2701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rot="16200000">
            <a:off x="-592092" y="3266306"/>
            <a:ext cx="1705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Total CE Content (Fold-Change) </a:t>
            </a:r>
          </a:p>
          <a:p>
            <a:endParaRPr lang="en-US" sz="900" b="1" dirty="0"/>
          </a:p>
        </p:txBody>
      </p:sp>
      <p:graphicFrame>
        <p:nvGraphicFramePr>
          <p:cNvPr id="4" name="Chart 3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90D7E915-A699-4DF7-9FA6-B5A1CD94B044}"/>
              </a:ext>
            </a:extLst>
          </p:cNvPr>
          <p:cNvGraphicFramePr>
            <a:graphicFrameLocks/>
          </p:cNvGraphicFramePr>
          <p:nvPr/>
        </p:nvGraphicFramePr>
        <p:xfrm>
          <a:off x="474106" y="1981200"/>
          <a:ext cx="6231493" cy="28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="" xmlns:p14="http://schemas.microsoft.com/office/powerpoint/2010/main" val="4603296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3</TotalTime>
  <Words>63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Nousheen Zaidi</dc:creator>
  <cp:lastModifiedBy>Rida Rashid</cp:lastModifiedBy>
  <cp:revision>244</cp:revision>
  <dcterms:created xsi:type="dcterms:W3CDTF">2017-10-04T17:41:58Z</dcterms:created>
  <dcterms:modified xsi:type="dcterms:W3CDTF">2019-04-06T22:06:58Z</dcterms:modified>
</cp:coreProperties>
</file>